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42" userDrawn="1">
          <p15:clr>
            <a:srgbClr val="A4A3A4"/>
          </p15:clr>
        </p15:guide>
        <p15:guide id="2" pos="10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2434" y="58"/>
      </p:cViewPr>
      <p:guideLst>
        <p:guide orient="horz" pos="1542"/>
        <p:guide pos="10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9631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9953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9740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5030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00663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4412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5932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845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8589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1584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2710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A7B34-034F-490A-A240-EEF2C4C39CAE}" type="datetimeFigureOut">
              <a:rPr lang="en-CA" smtClean="0"/>
              <a:t>2023-01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F3EAE-07C9-475C-B6EC-1FE90FDC11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8848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fficeArt object" descr="Text Box 2"/>
          <p:cNvSpPr txBox="1"/>
          <p:nvPr/>
        </p:nvSpPr>
        <p:spPr>
          <a:xfrm>
            <a:off x="1577340" y="2300765"/>
            <a:ext cx="182880" cy="20335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4289" tIns="34289" rIns="34289" bIns="34289" numCol="1" anchor="t">
            <a:no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825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CA" sz="825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5" name="officeArt object" descr="C:\Users\mserajaz\Desktop\SYNWORKING\Fall 2020\Latest_June_data\plot\don\Multracks.Rectangular-Manhattan.DON.PPM.2017.DON.PPM.2018.DON.PPM.2019.jp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8"/>
          <a:stretch/>
        </p:blipFill>
        <p:spPr>
          <a:xfrm>
            <a:off x="1691640" y="2254567"/>
            <a:ext cx="3643313" cy="46800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2" name="Rectangle 1"/>
          <p:cNvSpPr/>
          <p:nvPr/>
        </p:nvSpPr>
        <p:spPr>
          <a:xfrm>
            <a:off x="898141" y="292476"/>
            <a:ext cx="523031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Additional Figure 4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. Manhattan plots of associations between SNPs and FHB traits in the SHDW panel across three years (2017-19). A)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Deoxynivalenol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content (DON ppm), B) The average of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Fusarium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Damaged Kernels (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FDKave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), C)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Fusarium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Head Blight Incidence (FHBINC), D)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Fusarium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Head Blight Index (FHBINX), and E) </a:t>
            </a:r>
            <a:r>
              <a:rPr lang="en-US" sz="1200" dirty="0" err="1">
                <a:latin typeface="Times New Roman" panose="02020603050405020304" pitchFamily="18" charset="0"/>
                <a:ea typeface="Arial Unicode MS" panose="020B0604020202020204" pitchFamily="34" charset="-128"/>
              </a:rPr>
              <a:t>Fusarium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Head Blight Severity (FHBSEV).</a:t>
            </a:r>
            <a:endParaRPr lang="en-CA" sz="1200" dirty="0"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04538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fficeArt object" descr="C:\Users\mserajaz\Desktop\SYNWORKING\Fall 2020\Latest_June_data\plot\fdk\Multracks.Rectangular-Manhattan.FDK.AVG.2017.FDK.AVG.2018.FDK.AVG.2019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1641360" y="2266950"/>
            <a:ext cx="3697200" cy="46800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3" name="officeArt object" descr="Text Box 2"/>
          <p:cNvSpPr txBox="1"/>
          <p:nvPr/>
        </p:nvSpPr>
        <p:spPr>
          <a:xfrm>
            <a:off x="1585400" y="2296716"/>
            <a:ext cx="203359" cy="20335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4289" tIns="34289" rIns="34289" bIns="34289" numCol="1" anchor="t">
            <a:no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825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CA" sz="825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5099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fficeArt object" descr="C:\Users\mserajaz\Desktop\SYNWORKING\Fall 2020\Latest_June_data\plot\inc\Multracks.Rectangular-Manhattan.FHBINC.2017.FHBINC.2018.FHBINC.2019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1648980" y="2263140"/>
            <a:ext cx="3697200" cy="46800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3" name="officeArt object" descr="Text Box 2"/>
          <p:cNvSpPr txBox="1"/>
          <p:nvPr/>
        </p:nvSpPr>
        <p:spPr>
          <a:xfrm>
            <a:off x="1585400" y="2296716"/>
            <a:ext cx="203359" cy="20335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4289" tIns="34289" rIns="34289" bIns="34289" numCol="1" anchor="t">
            <a:no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825" b="1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en-CA" sz="825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4172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fficeArt object" descr="C:\Users\mserajaz\Desktop\SYNWORKING\Fall 2020\Latest_June_data\plot\inx\Multracks.Rectangular-Manhattan.FHBINX.2017.FHBINX.2018.FHBINX.2019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1630680" y="2286000"/>
            <a:ext cx="3697200" cy="46800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3" name="officeArt object" descr="Text Box 2"/>
          <p:cNvSpPr txBox="1"/>
          <p:nvPr/>
        </p:nvSpPr>
        <p:spPr>
          <a:xfrm>
            <a:off x="1585400" y="2296716"/>
            <a:ext cx="203359" cy="20335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4289" tIns="34289" rIns="34289" bIns="34289" numCol="1" anchor="t">
            <a:no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825" b="1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en-CA" sz="825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165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fficeArt object" descr="C:\Users\mserajaz\Desktop\SYNWORKING\Fall 2020\Latest_June_data\plot\sev\Multracks.Rectangular-Manhattan.FHBSEV.2017.FHBSEV.2018.FHBSEV.2019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1638300" y="2286000"/>
            <a:ext cx="3697200" cy="46800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3" name="officeArt object" descr="Text Box 2"/>
          <p:cNvSpPr txBox="1"/>
          <p:nvPr/>
        </p:nvSpPr>
        <p:spPr>
          <a:xfrm>
            <a:off x="1585400" y="2296716"/>
            <a:ext cx="203359" cy="20335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4289" tIns="34289" rIns="34289" bIns="34289" numCol="1" anchor="t">
            <a:no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825" b="1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endParaRPr lang="en-CA" sz="825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724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75</Words>
  <Application>Microsoft Office PowerPoint</Application>
  <PresentationFormat>On-screen Show (4:3)</PresentationFormat>
  <Paragraphs>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ra Serajazari</dc:creator>
  <cp:lastModifiedBy>Mitra Serajazari</cp:lastModifiedBy>
  <cp:revision>4</cp:revision>
  <dcterms:created xsi:type="dcterms:W3CDTF">2022-08-04T13:27:39Z</dcterms:created>
  <dcterms:modified xsi:type="dcterms:W3CDTF">2023-01-10T18:25:00Z</dcterms:modified>
</cp:coreProperties>
</file>